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680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76E26A-7078-448F-8AEC-FFF687A959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54784-5FF2-4CC1-921A-8BB79DCFAD98}" type="datetimeFigureOut">
              <a:rPr lang="ja-JP" altLang="en-US"/>
              <a:pPr>
                <a:defRPr/>
              </a:pPr>
              <a:t>2021/5/29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BC8220-4DED-4074-BBC5-C0CC8B836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954F01-F25D-4D60-ADA5-91C3A4D6EF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28E55E-C530-4AA0-B7F8-25E83592573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6754431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94EEFD-047D-43CB-8F16-509433B329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5BCBAB-5799-4007-95B8-11D1D17DD87E}" type="datetimeFigureOut">
              <a:rPr lang="ja-JP" altLang="en-US"/>
              <a:pPr>
                <a:defRPr/>
              </a:pPr>
              <a:t>2021/5/29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7089AE-9A34-4BFA-A1AF-8478C366D4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EEF619-AADE-4976-A463-04AD8FA7E0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5F18E0-B414-4142-8D3E-F0AEA620812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9138127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565D97-597C-4F64-A7C1-7F0FF2D942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0A6F9F-3BF7-449D-9761-A98205C4DB40}" type="datetimeFigureOut">
              <a:rPr lang="ja-JP" altLang="en-US"/>
              <a:pPr>
                <a:defRPr/>
              </a:pPr>
              <a:t>2021/5/29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37BE2F-4C59-4FAC-A629-FB65A87E5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27E059-4EB9-4AEF-8A94-B44A7E5B2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7BFAC8-414B-4088-8C0B-3FFEFAA5626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557397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69B156-8563-4DE2-8A98-13D3C508E9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88F961-AAC8-4B7E-8ABD-D26846CF5927}" type="datetimeFigureOut">
              <a:rPr lang="ja-JP" altLang="en-US"/>
              <a:pPr>
                <a:defRPr/>
              </a:pPr>
              <a:t>2021/5/29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7EBF07-A447-4944-AFD0-46478E7EBF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4F571D-6893-43D1-B38C-3E50CE7720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ABDADC-4B79-4E04-A842-A988D1A1F5D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4074122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06743C-1294-495E-ACAA-4EAFA0D80F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05E8FE-7CAA-4D8D-A77E-C717CEF65274}" type="datetimeFigureOut">
              <a:rPr lang="ja-JP" altLang="en-US"/>
              <a:pPr>
                <a:defRPr/>
              </a:pPr>
              <a:t>2021/5/29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B91482-05DD-4DE0-8A8E-EFA483FBF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3C0FB4-6C20-4794-8FF7-05D181EF3B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A290B9-EAD4-4590-8C48-12147F93E42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889481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6A282943-3ECD-4839-B0BA-A0EE06395B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6CFD6E-4DD3-4A35-B727-1302BCB2C3DA}" type="datetimeFigureOut">
              <a:rPr lang="ja-JP" altLang="en-US"/>
              <a:pPr>
                <a:defRPr/>
              </a:pPr>
              <a:t>2021/5/29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D42A1575-FA45-4AA2-A150-2787C0921F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1F3C6A29-773F-49D4-A1D9-EE81760E1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50E856-1F9B-42B4-903C-97D4EA7036C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9248633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CE55ED70-4A9A-4E23-BD47-2D876BF73B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4F902B-A2A7-4DF4-8BE0-997AF0125715}" type="datetimeFigureOut">
              <a:rPr lang="ja-JP" altLang="en-US"/>
              <a:pPr>
                <a:defRPr/>
              </a:pPr>
              <a:t>2021/5/29</a:t>
            </a:fld>
            <a:endParaRPr lang="ja-JP" alt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7B753BE8-FC86-4EE2-BE1C-ADBE04A45D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4D6B6D61-BD4E-4EE6-ADB8-8213D1A90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E8CA65-894D-410D-AD89-B24AB3DCFD8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3729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8289B278-4187-45E6-801A-6142384DE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E56027-5552-486D-98D6-466A0B8F0241}" type="datetimeFigureOut">
              <a:rPr lang="ja-JP" altLang="en-US"/>
              <a:pPr>
                <a:defRPr/>
              </a:pPr>
              <a:t>2021/5/29</a:t>
            </a:fld>
            <a:endParaRPr lang="ja-JP" alt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A81A07EE-6198-47FA-ACE0-76B7386AA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721CE0F4-40FA-4F06-A47E-1E74457F89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AD5FDC-DF5D-44F0-B612-54DE262EA49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3105403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5B1A6CA9-00AC-4591-867A-0342EC3ED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EFF08C-9877-4B43-B004-E0782AB6F9FE}" type="datetimeFigureOut">
              <a:rPr lang="ja-JP" altLang="en-US"/>
              <a:pPr>
                <a:defRPr/>
              </a:pPr>
              <a:t>2021/5/29</a:t>
            </a:fld>
            <a:endParaRPr lang="ja-JP" alt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ED685CB9-4ADE-4BB7-AC4A-EDC7024679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86586338-9D4E-4C36-8D5E-8843170B50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D557F7-CD27-4897-A071-12B5FC16169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51777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EE748474-21DF-4187-9A87-120DB06910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FAE9B9-049E-4F0B-9BB5-3D0A861F916F}" type="datetimeFigureOut">
              <a:rPr lang="ja-JP" altLang="en-US"/>
              <a:pPr>
                <a:defRPr/>
              </a:pPr>
              <a:t>2021/5/29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84177A9D-93A6-4090-9EFB-00434B7F4E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8E8F7BB7-9CA3-4064-964A-8D0FFD5C69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F950B8-2A9B-4E61-9B50-3DA7220125F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36714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249E8867-E022-4250-9E1B-1166493B7A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3EFC42-6021-4C16-BEB7-3FD9A183DB70}" type="datetimeFigureOut">
              <a:rPr lang="ja-JP" altLang="en-US"/>
              <a:pPr>
                <a:defRPr/>
              </a:pPr>
              <a:t>2021/5/29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79B1585D-919D-4E9B-8A48-0A96C56F11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5B8825C6-229E-4A80-AE56-61712F7D9E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B1FC01-5BD3-4043-BD1E-8D5A0B64DC5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976480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BF91E3E2-F179-42AE-BCD3-CD870777A679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838200" y="365126"/>
            <a:ext cx="105156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D007FBE4-7C52-47B4-9E8C-18F1A93B63AE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47599C-0567-494E-B5BF-F7EBC37761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8EDBE867-ADB9-4297-8AD5-0B212C5BA82B}" type="datetimeFigureOut">
              <a:rPr lang="ja-JP" altLang="en-US"/>
              <a:pPr>
                <a:defRPr/>
              </a:pPr>
              <a:t>2021/5/29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0EB35C-B8D3-4811-8AD7-7B77792A84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7DDE0C-6FB5-4D21-838D-3E462ABDCC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2BDBA5D8-916C-47DF-B925-F41B9CE6415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078836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68">
            <a:extLst>
              <a:ext uri="{FF2B5EF4-FFF2-40B4-BE49-F238E27FC236}">
                <a16:creationId xmlns:a16="http://schemas.microsoft.com/office/drawing/2014/main" id="{6913E298-07E9-45DE-A9EB-714EB3F4C68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216793" y="2264396"/>
            <a:ext cx="2740458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              TTF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roportion</a:t>
            </a:r>
            <a:r>
              <a:rPr kumimoji="1" lang="ja-JP" altLang="en-US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urvival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66" name="グループ化 65">
            <a:extLst>
              <a:ext uri="{FF2B5EF4-FFF2-40B4-BE49-F238E27FC236}">
                <a16:creationId xmlns:a16="http://schemas.microsoft.com/office/drawing/2014/main" id="{72DD1470-52E3-4928-88F4-D4EF460B295E}"/>
              </a:ext>
            </a:extLst>
          </p:cNvPr>
          <p:cNvGrpSpPr/>
          <p:nvPr/>
        </p:nvGrpSpPr>
        <p:grpSpPr>
          <a:xfrm>
            <a:off x="4383247" y="4950124"/>
            <a:ext cx="3515326" cy="782876"/>
            <a:chOff x="905255" y="4852611"/>
            <a:chExt cx="2900199" cy="645889"/>
          </a:xfrm>
        </p:grpSpPr>
        <p:grpSp>
          <p:nvGrpSpPr>
            <p:cNvPr id="67" name="グループ化 66">
              <a:extLst>
                <a:ext uri="{FF2B5EF4-FFF2-40B4-BE49-F238E27FC236}">
                  <a16:creationId xmlns:a16="http://schemas.microsoft.com/office/drawing/2014/main" id="{64072A28-ECB8-4DD1-AB86-4638AB5CF812}"/>
                </a:ext>
              </a:extLst>
            </p:cNvPr>
            <p:cNvGrpSpPr/>
            <p:nvPr/>
          </p:nvGrpSpPr>
          <p:grpSpPr>
            <a:xfrm>
              <a:off x="905255" y="4852611"/>
              <a:ext cx="2455529" cy="410509"/>
              <a:chOff x="1043989" y="4686781"/>
              <a:chExt cx="2455529" cy="410509"/>
            </a:xfrm>
          </p:grpSpPr>
          <p:grpSp>
            <p:nvGrpSpPr>
              <p:cNvPr id="69" name="グループ化 5">
                <a:extLst>
                  <a:ext uri="{FF2B5EF4-FFF2-40B4-BE49-F238E27FC236}">
                    <a16:creationId xmlns:a16="http://schemas.microsoft.com/office/drawing/2014/main" id="{68F0727B-50BF-4CEB-A812-09DAD226F3B4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4006" y="4686781"/>
                <a:ext cx="2452605" cy="187401"/>
                <a:chOff x="7451475" y="2452572"/>
                <a:chExt cx="1599502" cy="122236"/>
              </a:xfrm>
            </p:grpSpPr>
            <p:sp>
              <p:nvSpPr>
                <p:cNvPr id="73" name="Rectangle 64">
                  <a:extLst>
                    <a:ext uri="{FF2B5EF4-FFF2-40B4-BE49-F238E27FC236}">
                      <a16:creationId xmlns:a16="http://schemas.microsoft.com/office/drawing/2014/main" id="{0F2BB01F-5537-418C-820C-A938843434E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39764" y="2452572"/>
                  <a:ext cx="1411213" cy="12223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 typeface="Arial" panose="020B0604020202020204" pitchFamily="34" charset="0"/>
                    <a:buNone/>
                    <a:tabLst/>
                    <a:defRPr/>
                  </a:pPr>
                  <a:r>
                    <a:rPr kumimoji="0" lang="en-US" altLang="ja-JP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ETS &lt; 20% (n=46): </a:t>
                  </a:r>
                  <a:r>
                    <a:rPr kumimoji="0" lang="en-US" altLang="ja-JP" sz="1200" b="1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mTTF</a:t>
                  </a:r>
                  <a:r>
                    <a:rPr kumimoji="0" lang="en-US" altLang="ja-JP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, 4.1m</a:t>
                  </a:r>
                  <a:endParaRPr kumimoji="0" lang="ja-JP" altLang="ja-JP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4" name="Line 69">
                  <a:extLst>
                    <a:ext uri="{FF2B5EF4-FFF2-40B4-BE49-F238E27FC236}">
                      <a16:creationId xmlns:a16="http://schemas.microsoft.com/office/drawing/2014/main" id="{7F2A3312-3FD0-4D32-9F5A-33FB00B7A28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75" y="2518586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FF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200" b="1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70" name="グループ化 6">
                <a:extLst>
                  <a:ext uri="{FF2B5EF4-FFF2-40B4-BE49-F238E27FC236}">
                    <a16:creationId xmlns:a16="http://schemas.microsoft.com/office/drawing/2014/main" id="{E1E49914-2559-428B-A849-8D530C5B0B52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3989" y="4909888"/>
                <a:ext cx="2455529" cy="187402"/>
                <a:chOff x="7451487" y="2664355"/>
                <a:chExt cx="1601414" cy="122236"/>
              </a:xfrm>
            </p:grpSpPr>
            <p:sp>
              <p:nvSpPr>
                <p:cNvPr id="71" name="Rectangle 66">
                  <a:extLst>
                    <a:ext uri="{FF2B5EF4-FFF2-40B4-BE49-F238E27FC236}">
                      <a16:creationId xmlns:a16="http://schemas.microsoft.com/office/drawing/2014/main" id="{5339167F-3138-4D09-AD0D-081A07801BC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41685" y="2664355"/>
                  <a:ext cx="1411216" cy="12223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 typeface="Arial" panose="020B0604020202020204" pitchFamily="34" charset="0"/>
                    <a:buNone/>
                    <a:tabLst/>
                    <a:defRPr/>
                  </a:pPr>
                  <a:r>
                    <a:rPr kumimoji="0" lang="en-US" altLang="ja-JP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ETS </a:t>
                  </a:r>
                  <a:r>
                    <a:rPr kumimoji="0" lang="en-US" altLang="ja-JP" sz="1200" b="1" i="0" u="sng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&gt;</a:t>
                  </a:r>
                  <a:r>
                    <a:rPr kumimoji="0" lang="en-US" altLang="ja-JP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 20% (n=81): </a:t>
                  </a:r>
                  <a:r>
                    <a:rPr kumimoji="0" lang="en-US" altLang="ja-JP" sz="1200" b="1" i="0" u="none" strike="noStrike" kern="1200" cap="none" spc="0" normalizeH="0" baseline="0" noProof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mTTF</a:t>
                  </a:r>
                  <a:r>
                    <a:rPr kumimoji="0" lang="en-US" altLang="ja-JP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, 7.7m</a:t>
                  </a:r>
                  <a:endParaRPr kumimoji="0" lang="ja-JP" altLang="ja-JP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2" name="Line 73">
                  <a:extLst>
                    <a:ext uri="{FF2B5EF4-FFF2-40B4-BE49-F238E27FC236}">
                      <a16:creationId xmlns:a16="http://schemas.microsoft.com/office/drawing/2014/main" id="{2CC3FAA9-2E64-417D-9CFD-129CD4937C6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87" y="2729921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0000FF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ja-JP" altLang="en-US" sz="1200" b="1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68" name="Rectangle 64">
              <a:extLst>
                <a:ext uri="{FF2B5EF4-FFF2-40B4-BE49-F238E27FC236}">
                  <a16:creationId xmlns:a16="http://schemas.microsoft.com/office/drawing/2014/main" id="{84ABDB54-99FD-4C4F-BA16-4891E81B30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3542" y="5311099"/>
              <a:ext cx="2841912" cy="1874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 typeface="Arial" panose="020B0604020202020204" pitchFamily="34" charset="0"/>
                <a:buNone/>
                <a:tabLst/>
                <a:defRPr/>
              </a:pPr>
              <a:r>
                <a:rPr kumimoji="0" lang="en-US" altLang="ja-JP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     HR 0.48 (95% CI; 0.33-0.70, </a:t>
              </a:r>
              <a:r>
                <a:rPr kumimoji="0" lang="en-US" altLang="ja-JP" sz="1200" b="1" i="1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P</a:t>
              </a:r>
              <a:r>
                <a:rPr kumimoji="0" lang="en-US" altLang="ja-JP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= &lt;.001)</a:t>
              </a:r>
              <a:endParaRPr kumimoji="0" lang="ja-JP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5" name="グループ化 74">
            <a:extLst>
              <a:ext uri="{FF2B5EF4-FFF2-40B4-BE49-F238E27FC236}">
                <a16:creationId xmlns:a16="http://schemas.microsoft.com/office/drawing/2014/main" id="{0EE1799A-0B86-4B95-9FA1-C6B2EE490F7C}"/>
              </a:ext>
            </a:extLst>
          </p:cNvPr>
          <p:cNvGrpSpPr/>
          <p:nvPr/>
        </p:nvGrpSpPr>
        <p:grpSpPr>
          <a:xfrm>
            <a:off x="3861785" y="1512954"/>
            <a:ext cx="4415930" cy="3086139"/>
            <a:chOff x="186673" y="119679"/>
            <a:chExt cx="3590055" cy="2508967"/>
          </a:xfrm>
        </p:grpSpPr>
        <p:sp>
          <p:nvSpPr>
            <p:cNvPr id="76" name="Rectangle 18">
              <a:extLst>
                <a:ext uri="{FF2B5EF4-FFF2-40B4-BE49-F238E27FC236}">
                  <a16:creationId xmlns:a16="http://schemas.microsoft.com/office/drawing/2014/main" id="{D0EABB0F-86B4-43D1-9064-83482A0CFD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673" y="2297106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7" name="Rectangle 19">
              <a:extLst>
                <a:ext uri="{FF2B5EF4-FFF2-40B4-BE49-F238E27FC236}">
                  <a16:creationId xmlns:a16="http://schemas.microsoft.com/office/drawing/2014/main" id="{DD4C9EE0-274D-46D4-BE2A-517777DC70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673" y="1862065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8" name="Rectangle 20">
              <a:extLst>
                <a:ext uri="{FF2B5EF4-FFF2-40B4-BE49-F238E27FC236}">
                  <a16:creationId xmlns:a16="http://schemas.microsoft.com/office/drawing/2014/main" id="{E04AF1B4-107D-40F8-99E1-C816499D3F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673" y="1425903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9" name="Rectangle 21">
              <a:extLst>
                <a:ext uri="{FF2B5EF4-FFF2-40B4-BE49-F238E27FC236}">
                  <a16:creationId xmlns:a16="http://schemas.microsoft.com/office/drawing/2014/main" id="{8FFE887D-CDFC-4E66-86EA-3F7A6473C9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673" y="989742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80" name="Rectangle 22">
              <a:extLst>
                <a:ext uri="{FF2B5EF4-FFF2-40B4-BE49-F238E27FC236}">
                  <a16:creationId xmlns:a16="http://schemas.microsoft.com/office/drawing/2014/main" id="{5E0FB7B0-F4CC-4E5D-8F0A-B97F6372BD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673" y="555840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81" name="Rectangle 23">
              <a:extLst>
                <a:ext uri="{FF2B5EF4-FFF2-40B4-BE49-F238E27FC236}">
                  <a16:creationId xmlns:a16="http://schemas.microsoft.com/office/drawing/2014/main" id="{C4A5FE74-3C6B-4345-B5C2-C9A39EFEA8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673" y="119679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82" name="Rectangle 25">
              <a:extLst>
                <a:ext uri="{FF2B5EF4-FFF2-40B4-BE49-F238E27FC236}">
                  <a16:creationId xmlns:a16="http://schemas.microsoft.com/office/drawing/2014/main" id="{00F12678-7DE7-4E1B-A4C0-E3D74DAB7F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6704" y="206676"/>
              <a:ext cx="3224894" cy="217854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83" name="Freeform 26">
              <a:extLst>
                <a:ext uri="{FF2B5EF4-FFF2-40B4-BE49-F238E27FC236}">
                  <a16:creationId xmlns:a16="http://schemas.microsoft.com/office/drawing/2014/main" id="{F3B968B7-5FF7-4938-8083-FBDA287B5788}"/>
                </a:ext>
              </a:extLst>
            </p:cNvPr>
            <p:cNvSpPr>
              <a:spLocks/>
            </p:cNvSpPr>
            <p:nvPr/>
          </p:nvSpPr>
          <p:spPr bwMode="auto">
            <a:xfrm>
              <a:off x="456704" y="206676"/>
              <a:ext cx="2131097" cy="2178547"/>
            </a:xfrm>
            <a:custGeom>
              <a:avLst/>
              <a:gdLst>
                <a:gd name="T0" fmla="*/ 45 w 943"/>
                <a:gd name="T1" fmla="*/ 0 h 964"/>
                <a:gd name="T2" fmla="*/ 51 w 943"/>
                <a:gd name="T3" fmla="*/ 21 h 964"/>
                <a:gd name="T4" fmla="*/ 54 w 943"/>
                <a:gd name="T5" fmla="*/ 63 h 964"/>
                <a:gd name="T6" fmla="*/ 70 w 943"/>
                <a:gd name="T7" fmla="*/ 84 h 964"/>
                <a:gd name="T8" fmla="*/ 75 w 943"/>
                <a:gd name="T9" fmla="*/ 105 h 964"/>
                <a:gd name="T10" fmla="*/ 80 w 943"/>
                <a:gd name="T11" fmla="*/ 147 h 964"/>
                <a:gd name="T12" fmla="*/ 88 w 943"/>
                <a:gd name="T13" fmla="*/ 189 h 964"/>
                <a:gd name="T14" fmla="*/ 92 w 943"/>
                <a:gd name="T15" fmla="*/ 209 h 964"/>
                <a:gd name="T16" fmla="*/ 97 w 943"/>
                <a:gd name="T17" fmla="*/ 231 h 964"/>
                <a:gd name="T18" fmla="*/ 99 w 943"/>
                <a:gd name="T19" fmla="*/ 251 h 964"/>
                <a:gd name="T20" fmla="*/ 102 w 943"/>
                <a:gd name="T21" fmla="*/ 293 h 964"/>
                <a:gd name="T22" fmla="*/ 110 w 943"/>
                <a:gd name="T23" fmla="*/ 314 h 964"/>
                <a:gd name="T24" fmla="*/ 118 w 943"/>
                <a:gd name="T25" fmla="*/ 335 h 964"/>
                <a:gd name="T26" fmla="*/ 133 w 943"/>
                <a:gd name="T27" fmla="*/ 356 h 964"/>
                <a:gd name="T28" fmla="*/ 156 w 943"/>
                <a:gd name="T29" fmla="*/ 377 h 964"/>
                <a:gd name="T30" fmla="*/ 170 w 943"/>
                <a:gd name="T31" fmla="*/ 398 h 964"/>
                <a:gd name="T32" fmla="*/ 175 w 943"/>
                <a:gd name="T33" fmla="*/ 419 h 964"/>
                <a:gd name="T34" fmla="*/ 184 w 943"/>
                <a:gd name="T35" fmla="*/ 440 h 964"/>
                <a:gd name="T36" fmla="*/ 190 w 943"/>
                <a:gd name="T37" fmla="*/ 482 h 964"/>
                <a:gd name="T38" fmla="*/ 201 w 943"/>
                <a:gd name="T39" fmla="*/ 503 h 964"/>
                <a:gd name="T40" fmla="*/ 203 w 943"/>
                <a:gd name="T41" fmla="*/ 524 h 964"/>
                <a:gd name="T42" fmla="*/ 224 w 943"/>
                <a:gd name="T43" fmla="*/ 545 h 964"/>
                <a:gd name="T44" fmla="*/ 225 w 943"/>
                <a:gd name="T45" fmla="*/ 587 h 964"/>
                <a:gd name="T46" fmla="*/ 254 w 943"/>
                <a:gd name="T47" fmla="*/ 608 h 964"/>
                <a:gd name="T48" fmla="*/ 263 w 943"/>
                <a:gd name="T49" fmla="*/ 629 h 964"/>
                <a:gd name="T50" fmla="*/ 279 w 943"/>
                <a:gd name="T51" fmla="*/ 650 h 964"/>
                <a:gd name="T52" fmla="*/ 312 w 943"/>
                <a:gd name="T53" fmla="*/ 671 h 964"/>
                <a:gd name="T54" fmla="*/ 355 w 943"/>
                <a:gd name="T55" fmla="*/ 691 h 964"/>
                <a:gd name="T56" fmla="*/ 360 w 943"/>
                <a:gd name="T57" fmla="*/ 713 h 964"/>
                <a:gd name="T58" fmla="*/ 389 w 943"/>
                <a:gd name="T59" fmla="*/ 733 h 964"/>
                <a:gd name="T60" fmla="*/ 390 w 943"/>
                <a:gd name="T61" fmla="*/ 775 h 964"/>
                <a:gd name="T62" fmla="*/ 436 w 943"/>
                <a:gd name="T63" fmla="*/ 796 h 964"/>
                <a:gd name="T64" fmla="*/ 479 w 943"/>
                <a:gd name="T65" fmla="*/ 817 h 964"/>
                <a:gd name="T66" fmla="*/ 555 w 943"/>
                <a:gd name="T67" fmla="*/ 838 h 964"/>
                <a:gd name="T68" fmla="*/ 588 w 943"/>
                <a:gd name="T69" fmla="*/ 880 h 964"/>
                <a:gd name="T70" fmla="*/ 620 w 943"/>
                <a:gd name="T71" fmla="*/ 901 h 964"/>
                <a:gd name="T72" fmla="*/ 688 w 943"/>
                <a:gd name="T73" fmla="*/ 922 h 964"/>
                <a:gd name="T74" fmla="*/ 943 w 943"/>
                <a:gd name="T75" fmla="*/ 922 h 9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</a:cxnLst>
              <a:rect l="0" t="0" r="r" b="b"/>
              <a:pathLst>
                <a:path w="943" h="964">
                  <a:moveTo>
                    <a:pt x="0" y="0"/>
                  </a:moveTo>
                  <a:lnTo>
                    <a:pt x="45" y="0"/>
                  </a:lnTo>
                  <a:lnTo>
                    <a:pt x="45" y="21"/>
                  </a:lnTo>
                  <a:lnTo>
                    <a:pt x="51" y="21"/>
                  </a:lnTo>
                  <a:lnTo>
                    <a:pt x="51" y="42"/>
                  </a:lnTo>
                  <a:lnTo>
                    <a:pt x="54" y="63"/>
                  </a:lnTo>
                  <a:lnTo>
                    <a:pt x="70" y="63"/>
                  </a:lnTo>
                  <a:lnTo>
                    <a:pt x="70" y="84"/>
                  </a:lnTo>
                  <a:lnTo>
                    <a:pt x="75" y="84"/>
                  </a:lnTo>
                  <a:lnTo>
                    <a:pt x="75" y="105"/>
                  </a:lnTo>
                  <a:lnTo>
                    <a:pt x="80" y="105"/>
                  </a:lnTo>
                  <a:lnTo>
                    <a:pt x="80" y="147"/>
                  </a:lnTo>
                  <a:lnTo>
                    <a:pt x="88" y="147"/>
                  </a:lnTo>
                  <a:lnTo>
                    <a:pt x="88" y="189"/>
                  </a:lnTo>
                  <a:lnTo>
                    <a:pt x="92" y="189"/>
                  </a:lnTo>
                  <a:lnTo>
                    <a:pt x="92" y="209"/>
                  </a:lnTo>
                  <a:lnTo>
                    <a:pt x="97" y="209"/>
                  </a:lnTo>
                  <a:lnTo>
                    <a:pt x="97" y="231"/>
                  </a:lnTo>
                  <a:lnTo>
                    <a:pt x="99" y="231"/>
                  </a:lnTo>
                  <a:lnTo>
                    <a:pt x="99" y="251"/>
                  </a:lnTo>
                  <a:lnTo>
                    <a:pt x="100" y="272"/>
                  </a:lnTo>
                  <a:lnTo>
                    <a:pt x="102" y="293"/>
                  </a:lnTo>
                  <a:lnTo>
                    <a:pt x="110" y="293"/>
                  </a:lnTo>
                  <a:lnTo>
                    <a:pt x="110" y="314"/>
                  </a:lnTo>
                  <a:lnTo>
                    <a:pt x="118" y="314"/>
                  </a:lnTo>
                  <a:lnTo>
                    <a:pt x="118" y="335"/>
                  </a:lnTo>
                  <a:lnTo>
                    <a:pt x="133" y="335"/>
                  </a:lnTo>
                  <a:lnTo>
                    <a:pt x="133" y="356"/>
                  </a:lnTo>
                  <a:lnTo>
                    <a:pt x="156" y="356"/>
                  </a:lnTo>
                  <a:lnTo>
                    <a:pt x="156" y="377"/>
                  </a:lnTo>
                  <a:lnTo>
                    <a:pt x="170" y="377"/>
                  </a:lnTo>
                  <a:lnTo>
                    <a:pt x="170" y="398"/>
                  </a:lnTo>
                  <a:lnTo>
                    <a:pt x="175" y="398"/>
                  </a:lnTo>
                  <a:lnTo>
                    <a:pt x="175" y="419"/>
                  </a:lnTo>
                  <a:lnTo>
                    <a:pt x="184" y="419"/>
                  </a:lnTo>
                  <a:lnTo>
                    <a:pt x="184" y="440"/>
                  </a:lnTo>
                  <a:lnTo>
                    <a:pt x="190" y="440"/>
                  </a:lnTo>
                  <a:lnTo>
                    <a:pt x="190" y="482"/>
                  </a:lnTo>
                  <a:lnTo>
                    <a:pt x="201" y="482"/>
                  </a:lnTo>
                  <a:lnTo>
                    <a:pt x="201" y="503"/>
                  </a:lnTo>
                  <a:lnTo>
                    <a:pt x="203" y="503"/>
                  </a:lnTo>
                  <a:lnTo>
                    <a:pt x="203" y="524"/>
                  </a:lnTo>
                  <a:lnTo>
                    <a:pt x="205" y="545"/>
                  </a:lnTo>
                  <a:lnTo>
                    <a:pt x="224" y="545"/>
                  </a:lnTo>
                  <a:lnTo>
                    <a:pt x="224" y="566"/>
                  </a:lnTo>
                  <a:lnTo>
                    <a:pt x="225" y="587"/>
                  </a:lnTo>
                  <a:lnTo>
                    <a:pt x="254" y="587"/>
                  </a:lnTo>
                  <a:lnTo>
                    <a:pt x="254" y="608"/>
                  </a:lnTo>
                  <a:lnTo>
                    <a:pt x="263" y="608"/>
                  </a:lnTo>
                  <a:lnTo>
                    <a:pt x="263" y="629"/>
                  </a:lnTo>
                  <a:lnTo>
                    <a:pt x="279" y="629"/>
                  </a:lnTo>
                  <a:lnTo>
                    <a:pt x="279" y="650"/>
                  </a:lnTo>
                  <a:lnTo>
                    <a:pt x="312" y="650"/>
                  </a:lnTo>
                  <a:lnTo>
                    <a:pt x="312" y="671"/>
                  </a:lnTo>
                  <a:lnTo>
                    <a:pt x="355" y="671"/>
                  </a:lnTo>
                  <a:lnTo>
                    <a:pt x="355" y="691"/>
                  </a:lnTo>
                  <a:lnTo>
                    <a:pt x="359" y="713"/>
                  </a:lnTo>
                  <a:lnTo>
                    <a:pt x="360" y="713"/>
                  </a:lnTo>
                  <a:lnTo>
                    <a:pt x="360" y="733"/>
                  </a:lnTo>
                  <a:lnTo>
                    <a:pt x="389" y="733"/>
                  </a:lnTo>
                  <a:lnTo>
                    <a:pt x="389" y="754"/>
                  </a:lnTo>
                  <a:lnTo>
                    <a:pt x="390" y="775"/>
                  </a:lnTo>
                  <a:lnTo>
                    <a:pt x="436" y="775"/>
                  </a:lnTo>
                  <a:lnTo>
                    <a:pt x="436" y="796"/>
                  </a:lnTo>
                  <a:lnTo>
                    <a:pt x="479" y="796"/>
                  </a:lnTo>
                  <a:lnTo>
                    <a:pt x="479" y="817"/>
                  </a:lnTo>
                  <a:lnTo>
                    <a:pt x="555" y="817"/>
                  </a:lnTo>
                  <a:lnTo>
                    <a:pt x="555" y="838"/>
                  </a:lnTo>
                  <a:lnTo>
                    <a:pt x="588" y="838"/>
                  </a:lnTo>
                  <a:lnTo>
                    <a:pt x="588" y="880"/>
                  </a:lnTo>
                  <a:lnTo>
                    <a:pt x="620" y="880"/>
                  </a:lnTo>
                  <a:lnTo>
                    <a:pt x="620" y="901"/>
                  </a:lnTo>
                  <a:lnTo>
                    <a:pt x="688" y="901"/>
                  </a:lnTo>
                  <a:lnTo>
                    <a:pt x="688" y="922"/>
                  </a:lnTo>
                  <a:lnTo>
                    <a:pt x="919" y="922"/>
                  </a:lnTo>
                  <a:lnTo>
                    <a:pt x="943" y="922"/>
                  </a:lnTo>
                  <a:lnTo>
                    <a:pt x="943" y="964"/>
                  </a:lnTo>
                </a:path>
              </a:pathLst>
            </a:cu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84" name="Freeform 27">
              <a:extLst>
                <a:ext uri="{FF2B5EF4-FFF2-40B4-BE49-F238E27FC236}">
                  <a16:creationId xmlns:a16="http://schemas.microsoft.com/office/drawing/2014/main" id="{3D280787-F866-4A3F-8B14-88EAE57EB75F}"/>
                </a:ext>
              </a:extLst>
            </p:cNvPr>
            <p:cNvSpPr>
              <a:spLocks/>
            </p:cNvSpPr>
            <p:nvPr/>
          </p:nvSpPr>
          <p:spPr bwMode="auto">
            <a:xfrm>
              <a:off x="456704" y="206676"/>
              <a:ext cx="3087040" cy="1981935"/>
            </a:xfrm>
            <a:custGeom>
              <a:avLst/>
              <a:gdLst>
                <a:gd name="T0" fmla="*/ 97 w 1366"/>
                <a:gd name="T1" fmla="*/ 0 h 877"/>
                <a:gd name="T2" fmla="*/ 102 w 1366"/>
                <a:gd name="T3" fmla="*/ 12 h 877"/>
                <a:gd name="T4" fmla="*/ 103 w 1366"/>
                <a:gd name="T5" fmla="*/ 24 h 877"/>
                <a:gd name="T6" fmla="*/ 107 w 1366"/>
                <a:gd name="T7" fmla="*/ 36 h 877"/>
                <a:gd name="T8" fmla="*/ 110 w 1366"/>
                <a:gd name="T9" fmla="*/ 60 h 877"/>
                <a:gd name="T10" fmla="*/ 127 w 1366"/>
                <a:gd name="T11" fmla="*/ 71 h 877"/>
                <a:gd name="T12" fmla="*/ 132 w 1366"/>
                <a:gd name="T13" fmla="*/ 83 h 877"/>
                <a:gd name="T14" fmla="*/ 138 w 1366"/>
                <a:gd name="T15" fmla="*/ 95 h 877"/>
                <a:gd name="T16" fmla="*/ 141 w 1366"/>
                <a:gd name="T17" fmla="*/ 107 h 877"/>
                <a:gd name="T18" fmla="*/ 152 w 1366"/>
                <a:gd name="T19" fmla="*/ 119 h 877"/>
                <a:gd name="T20" fmla="*/ 156 w 1366"/>
                <a:gd name="T21" fmla="*/ 131 h 877"/>
                <a:gd name="T22" fmla="*/ 163 w 1366"/>
                <a:gd name="T23" fmla="*/ 155 h 877"/>
                <a:gd name="T24" fmla="*/ 179 w 1366"/>
                <a:gd name="T25" fmla="*/ 166 h 877"/>
                <a:gd name="T26" fmla="*/ 181 w 1366"/>
                <a:gd name="T27" fmla="*/ 202 h 877"/>
                <a:gd name="T28" fmla="*/ 198 w 1366"/>
                <a:gd name="T29" fmla="*/ 214 h 877"/>
                <a:gd name="T30" fmla="*/ 203 w 1366"/>
                <a:gd name="T31" fmla="*/ 226 h 877"/>
                <a:gd name="T32" fmla="*/ 210 w 1366"/>
                <a:gd name="T33" fmla="*/ 238 h 877"/>
                <a:gd name="T34" fmla="*/ 216 w 1366"/>
                <a:gd name="T35" fmla="*/ 250 h 877"/>
                <a:gd name="T36" fmla="*/ 222 w 1366"/>
                <a:gd name="T37" fmla="*/ 262 h 877"/>
                <a:gd name="T38" fmla="*/ 233 w 1366"/>
                <a:gd name="T39" fmla="*/ 274 h 877"/>
                <a:gd name="T40" fmla="*/ 252 w 1366"/>
                <a:gd name="T41" fmla="*/ 285 h 877"/>
                <a:gd name="T42" fmla="*/ 257 w 1366"/>
                <a:gd name="T43" fmla="*/ 298 h 877"/>
                <a:gd name="T44" fmla="*/ 263 w 1366"/>
                <a:gd name="T45" fmla="*/ 309 h 877"/>
                <a:gd name="T46" fmla="*/ 276 w 1366"/>
                <a:gd name="T47" fmla="*/ 333 h 877"/>
                <a:gd name="T48" fmla="*/ 282 w 1366"/>
                <a:gd name="T49" fmla="*/ 345 h 877"/>
                <a:gd name="T50" fmla="*/ 290 w 1366"/>
                <a:gd name="T51" fmla="*/ 357 h 877"/>
                <a:gd name="T52" fmla="*/ 297 w 1366"/>
                <a:gd name="T53" fmla="*/ 369 h 877"/>
                <a:gd name="T54" fmla="*/ 301 w 1366"/>
                <a:gd name="T55" fmla="*/ 381 h 877"/>
                <a:gd name="T56" fmla="*/ 309 w 1366"/>
                <a:gd name="T57" fmla="*/ 393 h 877"/>
                <a:gd name="T58" fmla="*/ 311 w 1366"/>
                <a:gd name="T59" fmla="*/ 417 h 877"/>
                <a:gd name="T60" fmla="*/ 335 w 1366"/>
                <a:gd name="T61" fmla="*/ 428 h 877"/>
                <a:gd name="T62" fmla="*/ 346 w 1366"/>
                <a:gd name="T63" fmla="*/ 440 h 877"/>
                <a:gd name="T64" fmla="*/ 349 w 1366"/>
                <a:gd name="T65" fmla="*/ 452 h 877"/>
                <a:gd name="T66" fmla="*/ 366 w 1366"/>
                <a:gd name="T67" fmla="*/ 464 h 877"/>
                <a:gd name="T68" fmla="*/ 370 w 1366"/>
                <a:gd name="T69" fmla="*/ 500 h 877"/>
                <a:gd name="T70" fmla="*/ 376 w 1366"/>
                <a:gd name="T71" fmla="*/ 523 h 877"/>
                <a:gd name="T72" fmla="*/ 378 w 1366"/>
                <a:gd name="T73" fmla="*/ 559 h 877"/>
                <a:gd name="T74" fmla="*/ 389 w 1366"/>
                <a:gd name="T75" fmla="*/ 571 h 877"/>
                <a:gd name="T76" fmla="*/ 409 w 1366"/>
                <a:gd name="T77" fmla="*/ 583 h 877"/>
                <a:gd name="T78" fmla="*/ 427 w 1366"/>
                <a:gd name="T79" fmla="*/ 595 h 877"/>
                <a:gd name="T80" fmla="*/ 444 w 1366"/>
                <a:gd name="T81" fmla="*/ 607 h 877"/>
                <a:gd name="T82" fmla="*/ 454 w 1366"/>
                <a:gd name="T83" fmla="*/ 619 h 877"/>
                <a:gd name="T84" fmla="*/ 455 w 1366"/>
                <a:gd name="T85" fmla="*/ 631 h 877"/>
                <a:gd name="T86" fmla="*/ 469 w 1366"/>
                <a:gd name="T87" fmla="*/ 643 h 877"/>
                <a:gd name="T88" fmla="*/ 487 w 1366"/>
                <a:gd name="T89" fmla="*/ 655 h 877"/>
                <a:gd name="T90" fmla="*/ 523 w 1366"/>
                <a:gd name="T91" fmla="*/ 666 h 877"/>
                <a:gd name="T92" fmla="*/ 531 w 1366"/>
                <a:gd name="T93" fmla="*/ 678 h 877"/>
                <a:gd name="T94" fmla="*/ 607 w 1366"/>
                <a:gd name="T95" fmla="*/ 690 h 877"/>
                <a:gd name="T96" fmla="*/ 631 w 1366"/>
                <a:gd name="T97" fmla="*/ 703 h 877"/>
                <a:gd name="T98" fmla="*/ 687 w 1366"/>
                <a:gd name="T99" fmla="*/ 703 h 877"/>
                <a:gd name="T100" fmla="*/ 688 w 1366"/>
                <a:gd name="T101" fmla="*/ 716 h 877"/>
                <a:gd name="T102" fmla="*/ 709 w 1366"/>
                <a:gd name="T103" fmla="*/ 729 h 877"/>
                <a:gd name="T104" fmla="*/ 747 w 1366"/>
                <a:gd name="T105" fmla="*/ 742 h 877"/>
                <a:gd name="T106" fmla="*/ 767 w 1366"/>
                <a:gd name="T107" fmla="*/ 756 h 877"/>
                <a:gd name="T108" fmla="*/ 788 w 1366"/>
                <a:gd name="T109" fmla="*/ 770 h 877"/>
                <a:gd name="T110" fmla="*/ 806 w 1366"/>
                <a:gd name="T111" fmla="*/ 784 h 877"/>
                <a:gd name="T112" fmla="*/ 823 w 1366"/>
                <a:gd name="T113" fmla="*/ 797 h 877"/>
                <a:gd name="T114" fmla="*/ 843 w 1366"/>
                <a:gd name="T115" fmla="*/ 812 h 877"/>
                <a:gd name="T116" fmla="*/ 872 w 1366"/>
                <a:gd name="T117" fmla="*/ 812 h 877"/>
                <a:gd name="T118" fmla="*/ 969 w 1366"/>
                <a:gd name="T119" fmla="*/ 812 h 877"/>
                <a:gd name="T120" fmla="*/ 1000 w 1366"/>
                <a:gd name="T121" fmla="*/ 856 h 877"/>
                <a:gd name="T122" fmla="*/ 1054 w 1366"/>
                <a:gd name="T123" fmla="*/ 877 h 877"/>
                <a:gd name="T124" fmla="*/ 1198 w 1366"/>
                <a:gd name="T125" fmla="*/ 877 h 8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1366" h="877">
                  <a:moveTo>
                    <a:pt x="0" y="0"/>
                  </a:moveTo>
                  <a:lnTo>
                    <a:pt x="97" y="0"/>
                  </a:lnTo>
                  <a:lnTo>
                    <a:pt x="97" y="12"/>
                  </a:lnTo>
                  <a:lnTo>
                    <a:pt x="102" y="12"/>
                  </a:lnTo>
                  <a:lnTo>
                    <a:pt x="102" y="24"/>
                  </a:lnTo>
                  <a:lnTo>
                    <a:pt x="103" y="24"/>
                  </a:lnTo>
                  <a:lnTo>
                    <a:pt x="103" y="36"/>
                  </a:lnTo>
                  <a:lnTo>
                    <a:pt x="107" y="36"/>
                  </a:lnTo>
                  <a:lnTo>
                    <a:pt x="107" y="47"/>
                  </a:lnTo>
                  <a:lnTo>
                    <a:pt x="110" y="60"/>
                  </a:lnTo>
                  <a:lnTo>
                    <a:pt x="127" y="60"/>
                  </a:lnTo>
                  <a:lnTo>
                    <a:pt x="127" y="71"/>
                  </a:lnTo>
                  <a:lnTo>
                    <a:pt x="132" y="71"/>
                  </a:lnTo>
                  <a:lnTo>
                    <a:pt x="132" y="83"/>
                  </a:lnTo>
                  <a:lnTo>
                    <a:pt x="138" y="83"/>
                  </a:lnTo>
                  <a:lnTo>
                    <a:pt x="138" y="95"/>
                  </a:lnTo>
                  <a:lnTo>
                    <a:pt x="141" y="95"/>
                  </a:lnTo>
                  <a:lnTo>
                    <a:pt x="141" y="107"/>
                  </a:lnTo>
                  <a:lnTo>
                    <a:pt x="152" y="107"/>
                  </a:lnTo>
                  <a:lnTo>
                    <a:pt x="152" y="119"/>
                  </a:lnTo>
                  <a:lnTo>
                    <a:pt x="154" y="131"/>
                  </a:lnTo>
                  <a:lnTo>
                    <a:pt x="156" y="131"/>
                  </a:lnTo>
                  <a:lnTo>
                    <a:pt x="156" y="155"/>
                  </a:lnTo>
                  <a:lnTo>
                    <a:pt x="163" y="155"/>
                  </a:lnTo>
                  <a:lnTo>
                    <a:pt x="163" y="166"/>
                  </a:lnTo>
                  <a:lnTo>
                    <a:pt x="179" y="166"/>
                  </a:lnTo>
                  <a:lnTo>
                    <a:pt x="179" y="179"/>
                  </a:lnTo>
                  <a:lnTo>
                    <a:pt x="181" y="202"/>
                  </a:lnTo>
                  <a:lnTo>
                    <a:pt x="198" y="202"/>
                  </a:lnTo>
                  <a:lnTo>
                    <a:pt x="198" y="214"/>
                  </a:lnTo>
                  <a:lnTo>
                    <a:pt x="203" y="214"/>
                  </a:lnTo>
                  <a:lnTo>
                    <a:pt x="203" y="226"/>
                  </a:lnTo>
                  <a:lnTo>
                    <a:pt x="210" y="226"/>
                  </a:lnTo>
                  <a:lnTo>
                    <a:pt x="210" y="238"/>
                  </a:lnTo>
                  <a:lnTo>
                    <a:pt x="216" y="238"/>
                  </a:lnTo>
                  <a:lnTo>
                    <a:pt x="216" y="250"/>
                  </a:lnTo>
                  <a:lnTo>
                    <a:pt x="222" y="250"/>
                  </a:lnTo>
                  <a:lnTo>
                    <a:pt x="222" y="262"/>
                  </a:lnTo>
                  <a:lnTo>
                    <a:pt x="233" y="262"/>
                  </a:lnTo>
                  <a:lnTo>
                    <a:pt x="233" y="274"/>
                  </a:lnTo>
                  <a:lnTo>
                    <a:pt x="252" y="274"/>
                  </a:lnTo>
                  <a:lnTo>
                    <a:pt x="252" y="285"/>
                  </a:lnTo>
                  <a:lnTo>
                    <a:pt x="257" y="285"/>
                  </a:lnTo>
                  <a:lnTo>
                    <a:pt x="257" y="298"/>
                  </a:lnTo>
                  <a:lnTo>
                    <a:pt x="259" y="309"/>
                  </a:lnTo>
                  <a:lnTo>
                    <a:pt x="263" y="309"/>
                  </a:lnTo>
                  <a:lnTo>
                    <a:pt x="263" y="333"/>
                  </a:lnTo>
                  <a:lnTo>
                    <a:pt x="276" y="333"/>
                  </a:lnTo>
                  <a:lnTo>
                    <a:pt x="276" y="345"/>
                  </a:lnTo>
                  <a:lnTo>
                    <a:pt x="282" y="345"/>
                  </a:lnTo>
                  <a:lnTo>
                    <a:pt x="282" y="357"/>
                  </a:lnTo>
                  <a:lnTo>
                    <a:pt x="290" y="357"/>
                  </a:lnTo>
                  <a:lnTo>
                    <a:pt x="290" y="369"/>
                  </a:lnTo>
                  <a:lnTo>
                    <a:pt x="297" y="369"/>
                  </a:lnTo>
                  <a:lnTo>
                    <a:pt x="297" y="381"/>
                  </a:lnTo>
                  <a:lnTo>
                    <a:pt x="301" y="381"/>
                  </a:lnTo>
                  <a:lnTo>
                    <a:pt x="301" y="393"/>
                  </a:lnTo>
                  <a:lnTo>
                    <a:pt x="309" y="393"/>
                  </a:lnTo>
                  <a:lnTo>
                    <a:pt x="309" y="417"/>
                  </a:lnTo>
                  <a:lnTo>
                    <a:pt x="311" y="417"/>
                  </a:lnTo>
                  <a:lnTo>
                    <a:pt x="311" y="428"/>
                  </a:lnTo>
                  <a:lnTo>
                    <a:pt x="335" y="428"/>
                  </a:lnTo>
                  <a:lnTo>
                    <a:pt x="335" y="440"/>
                  </a:lnTo>
                  <a:lnTo>
                    <a:pt x="346" y="440"/>
                  </a:lnTo>
                  <a:lnTo>
                    <a:pt x="346" y="452"/>
                  </a:lnTo>
                  <a:lnTo>
                    <a:pt x="349" y="452"/>
                  </a:lnTo>
                  <a:lnTo>
                    <a:pt x="349" y="464"/>
                  </a:lnTo>
                  <a:lnTo>
                    <a:pt x="366" y="464"/>
                  </a:lnTo>
                  <a:lnTo>
                    <a:pt x="366" y="500"/>
                  </a:lnTo>
                  <a:lnTo>
                    <a:pt x="370" y="500"/>
                  </a:lnTo>
                  <a:lnTo>
                    <a:pt x="370" y="523"/>
                  </a:lnTo>
                  <a:lnTo>
                    <a:pt x="376" y="523"/>
                  </a:lnTo>
                  <a:lnTo>
                    <a:pt x="376" y="536"/>
                  </a:lnTo>
                  <a:lnTo>
                    <a:pt x="378" y="559"/>
                  </a:lnTo>
                  <a:lnTo>
                    <a:pt x="389" y="559"/>
                  </a:lnTo>
                  <a:lnTo>
                    <a:pt x="389" y="571"/>
                  </a:lnTo>
                  <a:lnTo>
                    <a:pt x="409" y="571"/>
                  </a:lnTo>
                  <a:lnTo>
                    <a:pt x="409" y="583"/>
                  </a:lnTo>
                  <a:lnTo>
                    <a:pt x="411" y="595"/>
                  </a:lnTo>
                  <a:lnTo>
                    <a:pt x="427" y="595"/>
                  </a:lnTo>
                  <a:lnTo>
                    <a:pt x="427" y="607"/>
                  </a:lnTo>
                  <a:lnTo>
                    <a:pt x="444" y="607"/>
                  </a:lnTo>
                  <a:lnTo>
                    <a:pt x="444" y="619"/>
                  </a:lnTo>
                  <a:lnTo>
                    <a:pt x="454" y="619"/>
                  </a:lnTo>
                  <a:lnTo>
                    <a:pt x="454" y="631"/>
                  </a:lnTo>
                  <a:lnTo>
                    <a:pt x="455" y="631"/>
                  </a:lnTo>
                  <a:lnTo>
                    <a:pt x="455" y="643"/>
                  </a:lnTo>
                  <a:lnTo>
                    <a:pt x="469" y="643"/>
                  </a:lnTo>
                  <a:lnTo>
                    <a:pt x="469" y="655"/>
                  </a:lnTo>
                  <a:lnTo>
                    <a:pt x="487" y="655"/>
                  </a:lnTo>
                  <a:lnTo>
                    <a:pt x="487" y="666"/>
                  </a:lnTo>
                  <a:lnTo>
                    <a:pt x="523" y="666"/>
                  </a:lnTo>
                  <a:lnTo>
                    <a:pt x="523" y="678"/>
                  </a:lnTo>
                  <a:lnTo>
                    <a:pt x="531" y="678"/>
                  </a:lnTo>
                  <a:lnTo>
                    <a:pt x="531" y="690"/>
                  </a:lnTo>
                  <a:lnTo>
                    <a:pt x="607" y="690"/>
                  </a:lnTo>
                  <a:lnTo>
                    <a:pt x="631" y="690"/>
                  </a:lnTo>
                  <a:lnTo>
                    <a:pt x="631" y="703"/>
                  </a:lnTo>
                  <a:lnTo>
                    <a:pt x="640" y="703"/>
                  </a:lnTo>
                  <a:lnTo>
                    <a:pt x="687" y="703"/>
                  </a:lnTo>
                  <a:lnTo>
                    <a:pt x="687" y="716"/>
                  </a:lnTo>
                  <a:lnTo>
                    <a:pt x="688" y="716"/>
                  </a:lnTo>
                  <a:lnTo>
                    <a:pt x="688" y="729"/>
                  </a:lnTo>
                  <a:lnTo>
                    <a:pt x="709" y="729"/>
                  </a:lnTo>
                  <a:lnTo>
                    <a:pt x="709" y="742"/>
                  </a:lnTo>
                  <a:lnTo>
                    <a:pt x="747" y="742"/>
                  </a:lnTo>
                  <a:lnTo>
                    <a:pt x="747" y="756"/>
                  </a:lnTo>
                  <a:lnTo>
                    <a:pt x="767" y="756"/>
                  </a:lnTo>
                  <a:lnTo>
                    <a:pt x="767" y="770"/>
                  </a:lnTo>
                  <a:lnTo>
                    <a:pt x="788" y="770"/>
                  </a:lnTo>
                  <a:lnTo>
                    <a:pt x="788" y="784"/>
                  </a:lnTo>
                  <a:lnTo>
                    <a:pt x="806" y="784"/>
                  </a:lnTo>
                  <a:lnTo>
                    <a:pt x="806" y="797"/>
                  </a:lnTo>
                  <a:lnTo>
                    <a:pt x="823" y="797"/>
                  </a:lnTo>
                  <a:lnTo>
                    <a:pt x="843" y="797"/>
                  </a:lnTo>
                  <a:lnTo>
                    <a:pt x="843" y="812"/>
                  </a:lnTo>
                  <a:lnTo>
                    <a:pt x="859" y="812"/>
                  </a:lnTo>
                  <a:lnTo>
                    <a:pt x="872" y="812"/>
                  </a:lnTo>
                  <a:lnTo>
                    <a:pt x="908" y="812"/>
                  </a:lnTo>
                  <a:lnTo>
                    <a:pt x="969" y="812"/>
                  </a:lnTo>
                  <a:lnTo>
                    <a:pt x="969" y="856"/>
                  </a:lnTo>
                  <a:lnTo>
                    <a:pt x="1000" y="856"/>
                  </a:lnTo>
                  <a:lnTo>
                    <a:pt x="1000" y="877"/>
                  </a:lnTo>
                  <a:lnTo>
                    <a:pt x="1054" y="877"/>
                  </a:lnTo>
                  <a:lnTo>
                    <a:pt x="1072" y="877"/>
                  </a:lnTo>
                  <a:lnTo>
                    <a:pt x="1198" y="877"/>
                  </a:lnTo>
                  <a:lnTo>
                    <a:pt x="1366" y="877"/>
                  </a:lnTo>
                </a:path>
              </a:pathLst>
            </a:custGeom>
            <a:noFill/>
            <a:ln w="19050" cap="flat">
              <a:solidFill>
                <a:srgbClr val="0070C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ＭＳ Ｐゴシック" panose="020B0600070205080204" pitchFamily="50" charset="-128"/>
                <a:cs typeface="+mn-cs"/>
              </a:endParaRPr>
            </a:p>
          </p:txBody>
        </p:sp>
        <p:grpSp>
          <p:nvGrpSpPr>
            <p:cNvPr id="85" name="グループ化 84">
              <a:extLst>
                <a:ext uri="{FF2B5EF4-FFF2-40B4-BE49-F238E27FC236}">
                  <a16:creationId xmlns:a16="http://schemas.microsoft.com/office/drawing/2014/main" id="{63C53B9D-A2B5-43EB-81F4-E45B5D2A9D15}"/>
                </a:ext>
              </a:extLst>
            </p:cNvPr>
            <p:cNvGrpSpPr/>
            <p:nvPr/>
          </p:nvGrpSpPr>
          <p:grpSpPr>
            <a:xfrm>
              <a:off x="406986" y="211196"/>
              <a:ext cx="54238" cy="2232784"/>
              <a:chOff x="406986" y="211196"/>
              <a:chExt cx="54238" cy="2232784"/>
            </a:xfrm>
          </p:grpSpPr>
          <p:sp>
            <p:nvSpPr>
              <p:cNvPr id="109" name="Line 7">
                <a:extLst>
                  <a:ext uri="{FF2B5EF4-FFF2-40B4-BE49-F238E27FC236}">
                    <a16:creationId xmlns:a16="http://schemas.microsoft.com/office/drawing/2014/main" id="{59EF4AEF-CA0C-4F20-8400-54B11E12010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4104" y="2170532"/>
                <a:ext cx="27119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10" name="Line 8">
                <a:extLst>
                  <a:ext uri="{FF2B5EF4-FFF2-40B4-BE49-F238E27FC236}">
                    <a16:creationId xmlns:a16="http://schemas.microsoft.com/office/drawing/2014/main" id="{2EC58670-3087-49A2-A76F-DCD9AFEB90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4104" y="1736630"/>
                <a:ext cx="27119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11" name="Line 9">
                <a:extLst>
                  <a:ext uri="{FF2B5EF4-FFF2-40B4-BE49-F238E27FC236}">
                    <a16:creationId xmlns:a16="http://schemas.microsoft.com/office/drawing/2014/main" id="{6DA28346-45A9-4059-ADB7-5BFF1220FA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4104" y="1300469"/>
                <a:ext cx="27119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12" name="Line 10">
                <a:extLst>
                  <a:ext uri="{FF2B5EF4-FFF2-40B4-BE49-F238E27FC236}">
                    <a16:creationId xmlns:a16="http://schemas.microsoft.com/office/drawing/2014/main" id="{FA09A641-1840-496D-801C-93C5B1E8F9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4104" y="864308"/>
                <a:ext cx="27119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13" name="Line 11">
                <a:extLst>
                  <a:ext uri="{FF2B5EF4-FFF2-40B4-BE49-F238E27FC236}">
                    <a16:creationId xmlns:a16="http://schemas.microsoft.com/office/drawing/2014/main" id="{E6DC88CA-B75D-4E72-AD2B-C9D2CAB47E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4104" y="428146"/>
                <a:ext cx="27119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14" name="Line 12">
                <a:extLst>
                  <a:ext uri="{FF2B5EF4-FFF2-40B4-BE49-F238E27FC236}">
                    <a16:creationId xmlns:a16="http://schemas.microsoft.com/office/drawing/2014/main" id="{DE1485CF-F2FC-464F-BEE9-0E1CF14C071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6986" y="2389742"/>
                <a:ext cx="54238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15" name="Line 13">
                <a:extLst>
                  <a:ext uri="{FF2B5EF4-FFF2-40B4-BE49-F238E27FC236}">
                    <a16:creationId xmlns:a16="http://schemas.microsoft.com/office/drawing/2014/main" id="{F0E70F36-709F-4E73-B95B-B59201DA37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6986" y="1953581"/>
                <a:ext cx="54238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16" name="Line 14">
                <a:extLst>
                  <a:ext uri="{FF2B5EF4-FFF2-40B4-BE49-F238E27FC236}">
                    <a16:creationId xmlns:a16="http://schemas.microsoft.com/office/drawing/2014/main" id="{D5B391C6-432C-44C3-8759-0CA161F4F3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6986" y="1517420"/>
                <a:ext cx="54238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17" name="Line 15">
                <a:extLst>
                  <a:ext uri="{FF2B5EF4-FFF2-40B4-BE49-F238E27FC236}">
                    <a16:creationId xmlns:a16="http://schemas.microsoft.com/office/drawing/2014/main" id="{1420EF79-A2D2-45E4-B677-1938E5195F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6986" y="1081258"/>
                <a:ext cx="54238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18" name="Line 16">
                <a:extLst>
                  <a:ext uri="{FF2B5EF4-FFF2-40B4-BE49-F238E27FC236}">
                    <a16:creationId xmlns:a16="http://schemas.microsoft.com/office/drawing/2014/main" id="{2A641C94-7B5B-4B44-BBA4-752DF18CD6B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6986" y="647357"/>
                <a:ext cx="54238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19" name="Line 17">
                <a:extLst>
                  <a:ext uri="{FF2B5EF4-FFF2-40B4-BE49-F238E27FC236}">
                    <a16:creationId xmlns:a16="http://schemas.microsoft.com/office/drawing/2014/main" id="{DB435D65-469B-4EA9-8BEB-86E1DE23AB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6986" y="211196"/>
                <a:ext cx="54238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20" name="Line 35">
                <a:extLst>
                  <a:ext uri="{FF2B5EF4-FFF2-40B4-BE49-F238E27FC236}">
                    <a16:creationId xmlns:a16="http://schemas.microsoft.com/office/drawing/2014/main" id="{4770AFD0-5CC2-4A1B-B383-6C839559F4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61223" y="2389742"/>
                <a:ext cx="0" cy="54238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grpSp>
          <p:nvGrpSpPr>
            <p:cNvPr id="86" name="グループ化 85">
              <a:extLst>
                <a:ext uri="{FF2B5EF4-FFF2-40B4-BE49-F238E27FC236}">
                  <a16:creationId xmlns:a16="http://schemas.microsoft.com/office/drawing/2014/main" id="{BAA18002-B998-4A84-9DEB-7C92C08D134D}"/>
                </a:ext>
              </a:extLst>
            </p:cNvPr>
            <p:cNvGrpSpPr/>
            <p:nvPr/>
          </p:nvGrpSpPr>
          <p:grpSpPr>
            <a:xfrm>
              <a:off x="732413" y="2389742"/>
              <a:ext cx="2953705" cy="54238"/>
              <a:chOff x="732413" y="2389742"/>
              <a:chExt cx="2953705" cy="54238"/>
            </a:xfrm>
          </p:grpSpPr>
          <p:sp>
            <p:nvSpPr>
              <p:cNvPr id="97" name="Line 29">
                <a:extLst>
                  <a:ext uri="{FF2B5EF4-FFF2-40B4-BE49-F238E27FC236}">
                    <a16:creationId xmlns:a16="http://schemas.microsoft.com/office/drawing/2014/main" id="{0EAD3060-48AD-4C68-995A-46664DD23E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2413" y="2389742"/>
                <a:ext cx="0" cy="27119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98" name="Line 30">
                <a:extLst>
                  <a:ext uri="{FF2B5EF4-FFF2-40B4-BE49-F238E27FC236}">
                    <a16:creationId xmlns:a16="http://schemas.microsoft.com/office/drawing/2014/main" id="{B77B8B1A-99EE-4C1C-B5E7-18DF18C816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68012" y="2389742"/>
                <a:ext cx="0" cy="27119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99" name="Line 31">
                <a:extLst>
                  <a:ext uri="{FF2B5EF4-FFF2-40B4-BE49-F238E27FC236}">
                    <a16:creationId xmlns:a16="http://schemas.microsoft.com/office/drawing/2014/main" id="{61C6BD5A-5BF1-4AEB-87B7-B75FCDDF00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01351" y="2389742"/>
                <a:ext cx="0" cy="27119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0" name="Line 32">
                <a:extLst>
                  <a:ext uri="{FF2B5EF4-FFF2-40B4-BE49-F238E27FC236}">
                    <a16:creationId xmlns:a16="http://schemas.microsoft.com/office/drawing/2014/main" id="{12F70CFD-837F-4E4F-A664-98AE3E9413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5990" y="2389742"/>
                <a:ext cx="0" cy="27119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1" name="Line 33">
                <a:extLst>
                  <a:ext uri="{FF2B5EF4-FFF2-40B4-BE49-F238E27FC236}">
                    <a16:creationId xmlns:a16="http://schemas.microsoft.com/office/drawing/2014/main" id="{49E476AD-92C2-4EF4-8DAC-4C17363851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79329" y="2389742"/>
                <a:ext cx="0" cy="27119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2" name="Line 34">
                <a:extLst>
                  <a:ext uri="{FF2B5EF4-FFF2-40B4-BE49-F238E27FC236}">
                    <a16:creationId xmlns:a16="http://schemas.microsoft.com/office/drawing/2014/main" id="{4CDEB566-529B-4B7A-AE34-B7281354F8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12668" y="2389742"/>
                <a:ext cx="0" cy="27119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3" name="Line 36">
                <a:extLst>
                  <a:ext uri="{FF2B5EF4-FFF2-40B4-BE49-F238E27FC236}">
                    <a16:creationId xmlns:a16="http://schemas.microsoft.com/office/drawing/2014/main" id="{0D5ABA0E-9C56-47C2-A302-C3FD4FF019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96823" y="2389742"/>
                <a:ext cx="0" cy="54238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4" name="Line 37">
                <a:extLst>
                  <a:ext uri="{FF2B5EF4-FFF2-40B4-BE49-F238E27FC236}">
                    <a16:creationId xmlns:a16="http://schemas.microsoft.com/office/drawing/2014/main" id="{70EDC4C5-E3C0-4A46-AC6C-EB6BAB13C2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39201" y="2389742"/>
                <a:ext cx="0" cy="54238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5" name="Line 38">
                <a:extLst>
                  <a:ext uri="{FF2B5EF4-FFF2-40B4-BE49-F238E27FC236}">
                    <a16:creationId xmlns:a16="http://schemas.microsoft.com/office/drawing/2014/main" id="{A071BFD4-4E07-4BE3-95B5-B85792D40B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72541" y="2389742"/>
                <a:ext cx="0" cy="54238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6" name="Line 39">
                <a:extLst>
                  <a:ext uri="{FF2B5EF4-FFF2-40B4-BE49-F238E27FC236}">
                    <a16:creationId xmlns:a16="http://schemas.microsoft.com/office/drawing/2014/main" id="{F59603A4-C328-48BE-9EFD-BD68910A51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08140" y="2389742"/>
                <a:ext cx="0" cy="54238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7" name="Line 40">
                <a:extLst>
                  <a:ext uri="{FF2B5EF4-FFF2-40B4-BE49-F238E27FC236}">
                    <a16:creationId xmlns:a16="http://schemas.microsoft.com/office/drawing/2014/main" id="{01FD26A8-0460-4D58-ADB1-ADDF15763BB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50519" y="2389742"/>
                <a:ext cx="0" cy="54238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08" name="Line 41">
                <a:extLst>
                  <a:ext uri="{FF2B5EF4-FFF2-40B4-BE49-F238E27FC236}">
                    <a16:creationId xmlns:a16="http://schemas.microsoft.com/office/drawing/2014/main" id="{676F2EAE-069D-43D9-BEFC-F01DDBA45C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86118" y="2389742"/>
                <a:ext cx="0" cy="54238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sp>
          <p:nvSpPr>
            <p:cNvPr id="87" name="Rectangle 42">
              <a:extLst>
                <a:ext uri="{FF2B5EF4-FFF2-40B4-BE49-F238E27FC236}">
                  <a16:creationId xmlns:a16="http://schemas.microsoft.com/office/drawing/2014/main" id="{6031BE96-FCAB-4D9D-89DA-E100AAD1FC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5065" y="2443980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2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88" name="Rectangle 43">
              <a:extLst>
                <a:ext uri="{FF2B5EF4-FFF2-40B4-BE49-F238E27FC236}">
                  <a16:creationId xmlns:a16="http://schemas.microsoft.com/office/drawing/2014/main" id="{3759332E-375E-4CAE-962E-3AAFA66D34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0664" y="2443980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</a:t>
              </a:r>
              <a:endParaRPr kumimoji="0" lang="ja-JP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89" name="Rectangle 44">
              <a:extLst>
                <a:ext uri="{FF2B5EF4-FFF2-40B4-BE49-F238E27FC236}">
                  <a16:creationId xmlns:a16="http://schemas.microsoft.com/office/drawing/2014/main" id="{E5EF37AA-E149-438E-8995-C4F85B1C08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5924" y="2443980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0" name="Rectangle 45">
              <a:extLst>
                <a:ext uri="{FF2B5EF4-FFF2-40B4-BE49-F238E27FC236}">
                  <a16:creationId xmlns:a16="http://schemas.microsoft.com/office/drawing/2014/main" id="{D6776742-52DE-4F5A-B22E-04DECC1EC2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9263" y="2443980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5</a:t>
              </a:r>
              <a:endParaRPr kumimoji="0" lang="ja-JP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1" name="Rectangle 46">
              <a:extLst>
                <a:ext uri="{FF2B5EF4-FFF2-40B4-BE49-F238E27FC236}">
                  <a16:creationId xmlns:a16="http://schemas.microsoft.com/office/drawing/2014/main" id="{D39F7E3A-439C-4D55-B07A-E7DE5AEED8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4862" y="2443980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0" lang="ja-JP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2" name="Rectangle 47">
              <a:extLst>
                <a:ext uri="{FF2B5EF4-FFF2-40B4-BE49-F238E27FC236}">
                  <a16:creationId xmlns:a16="http://schemas.microsoft.com/office/drawing/2014/main" id="{EF585733-3C4F-452B-B2D5-07527C29B6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87241" y="2443980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5</a:t>
              </a:r>
              <a:endParaRPr kumimoji="0" lang="ja-JP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3" name="Rectangle 48">
              <a:extLst>
                <a:ext uri="{FF2B5EF4-FFF2-40B4-BE49-F238E27FC236}">
                  <a16:creationId xmlns:a16="http://schemas.microsoft.com/office/drawing/2014/main" id="{83E6A6B4-37E2-45C6-8E89-34DD25DD07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22840" y="2443980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ja-JP" altLang="ja-JP" sz="12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30</a:t>
              </a:r>
              <a:endParaRPr kumimoji="0" lang="ja-JP" altLang="ja-JP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grpSp>
          <p:nvGrpSpPr>
            <p:cNvPr id="94" name="グループ化 110">
              <a:extLst>
                <a:ext uri="{FF2B5EF4-FFF2-40B4-BE49-F238E27FC236}">
                  <a16:creationId xmlns:a16="http://schemas.microsoft.com/office/drawing/2014/main" id="{862F957C-F189-42DE-9088-697C466EFD43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57594" y="221260"/>
              <a:ext cx="3160581" cy="2167561"/>
              <a:chOff x="7724724" y="2752488"/>
              <a:chExt cx="3207388" cy="2200120"/>
            </a:xfrm>
          </p:grpSpPr>
          <p:cxnSp>
            <p:nvCxnSpPr>
              <p:cNvPr id="95" name="直線コネクタ 94">
                <a:extLst>
                  <a:ext uri="{FF2B5EF4-FFF2-40B4-BE49-F238E27FC236}">
                    <a16:creationId xmlns:a16="http://schemas.microsoft.com/office/drawing/2014/main" id="{3DE58AC7-45CA-40BC-A12C-B92CFB61E51E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728112" y="4952608"/>
                <a:ext cx="3204000" cy="0"/>
              </a:xfrm>
              <a:prstGeom prst="line">
                <a:avLst/>
              </a:prstGeom>
              <a:noFill/>
              <a:ln w="12700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96" name="直線コネクタ 95">
                <a:extLst>
                  <a:ext uri="{FF2B5EF4-FFF2-40B4-BE49-F238E27FC236}">
                    <a16:creationId xmlns:a16="http://schemas.microsoft.com/office/drawing/2014/main" id="{F0235537-5EF5-445D-AA2D-0808C9FCED78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724724" y="2752488"/>
                <a:ext cx="0" cy="2196000"/>
              </a:xfrm>
              <a:prstGeom prst="line">
                <a:avLst/>
              </a:prstGeom>
              <a:noFill/>
              <a:ln w="12700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</p:grp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A542664-85CD-4069-9738-FC7CDCE0F38F}"/>
              </a:ext>
            </a:extLst>
          </p:cNvPr>
          <p:cNvSpPr txBox="1"/>
          <p:nvPr/>
        </p:nvSpPr>
        <p:spPr bwMode="auto">
          <a:xfrm>
            <a:off x="5876250" y="2972856"/>
            <a:ext cx="1874171" cy="416436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P</a:t>
            </a:r>
            <a:r>
              <a:rPr kumimoji="1" lang="en-US" altLang="ja-JP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 = &lt; .001</a:t>
            </a:r>
            <a:endParaRPr kumimoji="1" lang="ja-JP" altLang="en-US" sz="16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ＭＳ Ｐゴシック" charset="-128"/>
              <a:cs typeface="Times New Roman" panose="02020603050405020304" pitchFamily="18" charset="0"/>
            </a:endParaRPr>
          </a:p>
        </p:txBody>
      </p:sp>
      <p:sp>
        <p:nvSpPr>
          <p:cNvPr id="123" name="Rectangle 50">
            <a:extLst>
              <a:ext uri="{FF2B5EF4-FFF2-40B4-BE49-F238E27FC236}">
                <a16:creationId xmlns:a16="http://schemas.microsoft.com/office/drawing/2014/main" id="{9F44C15A-565B-4E8B-8676-BEE92751F4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54828" y="4609733"/>
            <a:ext cx="1172168" cy="223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0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Time </a:t>
            </a:r>
            <a:r>
              <a:rPr kumimoji="0" lang="ja-JP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(month</a:t>
            </a:r>
            <a:r>
              <a:rPr kumimoji="0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s</a:t>
            </a:r>
            <a:r>
              <a:rPr kumimoji="0" lang="ja-JP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473" name="テキスト ボックス 406">
            <a:extLst>
              <a:ext uri="{FF2B5EF4-FFF2-40B4-BE49-F238E27FC236}">
                <a16:creationId xmlns:a16="http://schemas.microsoft.com/office/drawing/2014/main" id="{B4D1BF53-7AE5-4C3C-9763-4BB9183550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72000" y="0"/>
            <a:ext cx="23040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upplementary Figure</a:t>
            </a:r>
            <a:r>
              <a:rPr kumimoji="1" lang="ja-JP" alt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1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F98832D6-87BE-4D4B-9BED-05616F3F1EC1}"/>
              </a:ext>
            </a:extLst>
          </p:cNvPr>
          <p:cNvSpPr txBox="1"/>
          <p:nvPr/>
        </p:nvSpPr>
        <p:spPr>
          <a:xfrm>
            <a:off x="3225637" y="6111088"/>
            <a:ext cx="613460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b="1" dirty="0"/>
              <a:t>Supplementary Figure S1</a:t>
            </a:r>
            <a:r>
              <a:rPr lang="en-US" altLang="ja-JP" dirty="0"/>
              <a:t>: Kaplan-Meier curves of TTF according to the ETS status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00153219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8</TotalTime>
  <Words>81</Words>
  <Application>Microsoft Office PowerPoint</Application>
  <PresentationFormat>ワイド画面</PresentationFormat>
  <Paragraphs>2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1_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木 暁</dc:creator>
  <cp:lastModifiedBy>大木 暁</cp:lastModifiedBy>
  <cp:revision>3</cp:revision>
  <dcterms:created xsi:type="dcterms:W3CDTF">2021-01-16T02:41:31Z</dcterms:created>
  <dcterms:modified xsi:type="dcterms:W3CDTF">2021-05-29T03:41:25Z</dcterms:modified>
</cp:coreProperties>
</file>